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</p:sldIdLst>
  <p:sldSz cx="8999538" cy="15119350"/>
  <p:notesSz cx="9144000" cy="6858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89063" autoAdjust="0"/>
  </p:normalViewPr>
  <p:slideViewPr>
    <p:cSldViewPr snapToGrid="0">
      <p:cViewPr>
        <p:scale>
          <a:sx n="91" d="100"/>
          <a:sy n="91" d="100"/>
        </p:scale>
        <p:origin x="852" y="-57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2474395"/>
            <a:ext cx="7649607" cy="5263774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7941160"/>
            <a:ext cx="6749654" cy="3650342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D28C1-34E7-407F-A022-F93603C077D0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AB4-9016-4EA3-9AE7-C578A8D7A6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99567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D28C1-34E7-407F-A022-F93603C077D0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AB4-9016-4EA3-9AE7-C578A8D7A6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7102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804966"/>
            <a:ext cx="1940525" cy="1281295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804966"/>
            <a:ext cx="5709082" cy="12812950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D28C1-34E7-407F-A022-F93603C077D0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AB4-9016-4EA3-9AE7-C578A8D7A6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8113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D28C1-34E7-407F-A022-F93603C077D0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AB4-9016-4EA3-9AE7-C578A8D7A6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99232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3769342"/>
            <a:ext cx="7762102" cy="6289229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10118069"/>
            <a:ext cx="7762102" cy="3307357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D28C1-34E7-407F-A022-F93603C077D0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AB4-9016-4EA3-9AE7-C578A8D7A6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45030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4024827"/>
            <a:ext cx="3824804" cy="9593089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4024827"/>
            <a:ext cx="3824804" cy="9593089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D28C1-34E7-407F-A022-F93603C077D0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AB4-9016-4EA3-9AE7-C578A8D7A6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3594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804969"/>
            <a:ext cx="7762102" cy="292237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3706342"/>
            <a:ext cx="3807226" cy="181642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5522763"/>
            <a:ext cx="3807226" cy="8123152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3706342"/>
            <a:ext cx="3825976" cy="181642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5522763"/>
            <a:ext cx="3825976" cy="8123152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D28C1-34E7-407F-A022-F93603C077D0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AB4-9016-4EA3-9AE7-C578A8D7A6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03449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D28C1-34E7-407F-A022-F93603C077D0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AB4-9016-4EA3-9AE7-C578A8D7A6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6111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D28C1-34E7-407F-A022-F93603C077D0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AB4-9016-4EA3-9AE7-C578A8D7A6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3423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1007957"/>
            <a:ext cx="2902585" cy="3527848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2176910"/>
            <a:ext cx="4556016" cy="10744538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4535805"/>
            <a:ext cx="2902585" cy="8403140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D28C1-34E7-407F-A022-F93603C077D0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AB4-9016-4EA3-9AE7-C578A8D7A6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164224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1007957"/>
            <a:ext cx="2902585" cy="3527848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2176910"/>
            <a:ext cx="4556016" cy="10744538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4535805"/>
            <a:ext cx="2902585" cy="8403140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D28C1-34E7-407F-A022-F93603C077D0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885AB4-9016-4EA3-9AE7-C578A8D7A6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86816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804969"/>
            <a:ext cx="7762102" cy="29223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4024827"/>
            <a:ext cx="7762102" cy="959308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4013401"/>
            <a:ext cx="2024896" cy="8049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D28C1-34E7-407F-A022-F93603C077D0}" type="datetimeFigureOut">
              <a:rPr lang="it-IT" smtClean="0"/>
              <a:t>16/0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4013401"/>
            <a:ext cx="3037344" cy="8049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4013401"/>
            <a:ext cx="2024896" cy="8049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885AB4-9016-4EA3-9AE7-C578A8D7A6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87698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3170375" y="161793"/>
            <a:ext cx="2661855" cy="29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346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Palatino Linotype" panose="02040502050505030304" pitchFamily="18" charset="0"/>
              </a:rPr>
              <a:t>a) </a:t>
            </a:r>
            <a:r>
              <a:rPr lang="it-IT" sz="1346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Palatino Linotype" panose="02040502050505030304" pitchFamily="18" charset="0"/>
              </a:rPr>
              <a:t>CELLULAR COMPONENT</a:t>
            </a:r>
          </a:p>
        </p:txBody>
      </p:sp>
      <p:sp>
        <p:nvSpPr>
          <p:cNvPr id="7" name="Rettangolo 6"/>
          <p:cNvSpPr/>
          <p:nvPr/>
        </p:nvSpPr>
        <p:spPr>
          <a:xfrm>
            <a:off x="927413" y="922275"/>
            <a:ext cx="2267929" cy="16158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288550" indent="-288550">
              <a:buAutoNum type="alphaLcPeriod"/>
            </a:pPr>
            <a:r>
              <a:rPr lang="en-GB" sz="900" i="1" dirty="0">
                <a:latin typeface="Palatino Linotype" panose="02040502050505030304" pitchFamily="18" charset="0"/>
              </a:rPr>
              <a:t>Extracellular Matrix Component</a:t>
            </a:r>
          </a:p>
          <a:p>
            <a:pPr marL="288550" indent="-288550">
              <a:buAutoNum type="alphaLcPeriod"/>
            </a:pPr>
            <a:r>
              <a:rPr lang="en-GB" sz="900" i="1" dirty="0">
                <a:latin typeface="Palatino Linotype" panose="02040502050505030304" pitchFamily="18" charset="0"/>
              </a:rPr>
              <a:t>Lysosome</a:t>
            </a:r>
          </a:p>
          <a:p>
            <a:pPr marL="288550" indent="-288550">
              <a:buFontTx/>
              <a:buAutoNum type="alphaLcPeriod"/>
            </a:pPr>
            <a:r>
              <a:rPr lang="en-GB" sz="900" i="1" dirty="0">
                <a:latin typeface="Palatino Linotype" panose="02040502050505030304" pitchFamily="18" charset="0"/>
              </a:rPr>
              <a:t>Blood Microparticle </a:t>
            </a:r>
          </a:p>
          <a:p>
            <a:pPr marL="288550" indent="-288550">
              <a:buFontTx/>
              <a:buAutoNum type="alphaLcPeriod"/>
            </a:pPr>
            <a:r>
              <a:rPr lang="en-GB" sz="900" i="1" dirty="0">
                <a:latin typeface="Palatino Linotype" panose="02040502050505030304" pitchFamily="18" charset="0"/>
              </a:rPr>
              <a:t>Endocytic Vesicle </a:t>
            </a:r>
          </a:p>
          <a:p>
            <a:pPr marL="288550" indent="-288550">
              <a:buFontTx/>
              <a:buAutoNum type="alphaLcPeriod"/>
            </a:pPr>
            <a:r>
              <a:rPr lang="en-GB" sz="900" i="1" dirty="0">
                <a:latin typeface="Palatino Linotype" panose="02040502050505030304" pitchFamily="18" charset="0"/>
              </a:rPr>
              <a:t>Plasma Lipoprotein Particle </a:t>
            </a:r>
          </a:p>
          <a:p>
            <a:pPr marL="288550" indent="-288550">
              <a:buFontTx/>
              <a:buAutoNum type="alphaLcPeriod"/>
            </a:pPr>
            <a:r>
              <a:rPr lang="en-GB" sz="900" i="1" dirty="0">
                <a:latin typeface="Palatino Linotype" panose="02040502050505030304" pitchFamily="18" charset="0"/>
              </a:rPr>
              <a:t>Golgi and ER lumen </a:t>
            </a:r>
          </a:p>
          <a:p>
            <a:pPr marL="288550" indent="-288550">
              <a:buFontTx/>
              <a:buAutoNum type="alphaLcPeriod"/>
            </a:pPr>
            <a:r>
              <a:rPr lang="en-GB" sz="900" i="1" dirty="0">
                <a:latin typeface="Palatino Linotype" panose="02040502050505030304" pitchFamily="18" charset="0"/>
              </a:rPr>
              <a:t>Extracellular Vesicle </a:t>
            </a:r>
          </a:p>
          <a:p>
            <a:pPr marL="288550" indent="-288550">
              <a:buFontTx/>
              <a:buAutoNum type="alphaLcPeriod"/>
            </a:pPr>
            <a:r>
              <a:rPr lang="en-GB" sz="900" i="1" dirty="0">
                <a:latin typeface="Palatino Linotype" panose="02040502050505030304" pitchFamily="18" charset="0"/>
              </a:rPr>
              <a:t>Immunoglobulin Complex Circulating</a:t>
            </a:r>
          </a:p>
          <a:p>
            <a:pPr marL="288550" indent="-288550">
              <a:buFontTx/>
              <a:buAutoNum type="alphaLcPeriod"/>
            </a:pPr>
            <a:r>
              <a:rPr lang="en-GB" sz="900" i="1" dirty="0">
                <a:latin typeface="Palatino Linotype" panose="02040502050505030304" pitchFamily="18" charset="0"/>
              </a:rPr>
              <a:t>Vacuolar part </a:t>
            </a:r>
          </a:p>
          <a:p>
            <a:pPr marL="288550" indent="-288550">
              <a:buFontTx/>
              <a:buAutoNum type="alphaLcPeriod"/>
            </a:pPr>
            <a:r>
              <a:rPr lang="en-GB" sz="900" i="1" dirty="0">
                <a:latin typeface="Palatino Linotype" panose="02040502050505030304" pitchFamily="18" charset="0"/>
              </a:rPr>
              <a:t>Membrane Component </a:t>
            </a:r>
          </a:p>
          <a:p>
            <a:pPr marL="288550" indent="-288550">
              <a:buFontTx/>
              <a:buAutoNum type="alphaLcPeriod"/>
            </a:pPr>
            <a:r>
              <a:rPr lang="en-GB" sz="900" i="1" dirty="0">
                <a:latin typeface="Palatino Linotype" panose="02040502050505030304" pitchFamily="18" charset="0"/>
              </a:rPr>
              <a:t>Immune Secretory Vesicle </a:t>
            </a:r>
          </a:p>
        </p:txBody>
      </p:sp>
      <p:sp>
        <p:nvSpPr>
          <p:cNvPr id="50" name="CasellaDiTesto 49"/>
          <p:cNvSpPr txBox="1"/>
          <p:nvPr/>
        </p:nvSpPr>
        <p:spPr>
          <a:xfrm>
            <a:off x="3192341" y="4244369"/>
            <a:ext cx="2969070" cy="29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346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Palatino Linotype" panose="02040502050505030304" pitchFamily="18" charset="0"/>
              </a:rPr>
              <a:t>b) </a:t>
            </a:r>
            <a:r>
              <a:rPr lang="it-IT" sz="1346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Palatino Linotype" panose="02040502050505030304" pitchFamily="18" charset="0"/>
              </a:rPr>
              <a:t>MOLECULAR FUNCTION</a:t>
            </a:r>
          </a:p>
        </p:txBody>
      </p:sp>
      <p:sp>
        <p:nvSpPr>
          <p:cNvPr id="52" name="Rettangolo 51"/>
          <p:cNvSpPr/>
          <p:nvPr/>
        </p:nvSpPr>
        <p:spPr>
          <a:xfrm>
            <a:off x="3641614" y="4662223"/>
            <a:ext cx="329724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8550" indent="-288550">
              <a:buAutoNum type="alphaLcPeriod"/>
            </a:pPr>
            <a:r>
              <a:rPr lang="en-GB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Peptidase Activity </a:t>
            </a:r>
          </a:p>
          <a:p>
            <a:pPr marL="288550" indent="-288550">
              <a:buAutoNum type="alphaLcPeriod"/>
            </a:pPr>
            <a:r>
              <a:rPr lang="en-GB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Glycosaminoglycan And Proteoglycan Binding </a:t>
            </a:r>
          </a:p>
          <a:p>
            <a:pPr marL="288550" indent="-288550">
              <a:buAutoNum type="alphaLcPeriod"/>
            </a:pPr>
            <a:r>
              <a:rPr lang="en-GB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Immune Component Binding </a:t>
            </a:r>
          </a:p>
          <a:p>
            <a:pPr marL="288550" indent="-288550">
              <a:buAutoNum type="alphaLcPeriod"/>
            </a:pPr>
            <a:r>
              <a:rPr lang="en-GB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Receptor Activity </a:t>
            </a:r>
          </a:p>
          <a:p>
            <a:pPr marL="288550" indent="-288550">
              <a:buAutoNum type="alphaLcPeriod"/>
            </a:pPr>
            <a:r>
              <a:rPr lang="en-GB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Chaperone Binding </a:t>
            </a:r>
          </a:p>
          <a:p>
            <a:pPr marL="288550" indent="-288550">
              <a:buAutoNum type="alphaLcPeriod"/>
            </a:pPr>
            <a:r>
              <a:rPr lang="en-GB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Extracellular Matrix Structural Constituent </a:t>
            </a:r>
          </a:p>
          <a:p>
            <a:pPr marL="288550" indent="-288550">
              <a:buAutoNum type="alphaLcPeriod"/>
            </a:pPr>
            <a:r>
              <a:rPr lang="en-GB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Protease Binding </a:t>
            </a:r>
          </a:p>
          <a:p>
            <a:pPr marL="288550" indent="-288550">
              <a:buAutoNum type="alphaLcPeriod"/>
            </a:pPr>
            <a:endParaRPr lang="en-GB" sz="900" i="1" dirty="0">
              <a:solidFill>
                <a:srgbClr val="00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77" name="Rettangolo 76"/>
          <p:cNvSpPr/>
          <p:nvPr/>
        </p:nvSpPr>
        <p:spPr>
          <a:xfrm>
            <a:off x="6196591" y="4655375"/>
            <a:ext cx="272137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8550" indent="-288550">
              <a:buFont typeface="+mj-lt"/>
              <a:buAutoNum type="alphaLcPeriod" startAt="8"/>
            </a:pPr>
            <a:r>
              <a:rPr lang="en-GB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Phosphatidylcholine Binding </a:t>
            </a:r>
          </a:p>
          <a:p>
            <a:pPr marL="288550" indent="-288550">
              <a:buFont typeface="+mj-lt"/>
              <a:buAutoNum type="alphaLcPeriod" startAt="8"/>
            </a:pPr>
            <a:r>
              <a:rPr lang="en-GB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Peptidase Regulator Activity </a:t>
            </a:r>
          </a:p>
          <a:p>
            <a:pPr marL="288550" indent="-288550">
              <a:buFont typeface="+mj-lt"/>
              <a:buAutoNum type="alphaLcPeriod" startAt="8"/>
            </a:pPr>
            <a:r>
              <a:rPr lang="en-GB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Haemoglobin Binding </a:t>
            </a:r>
          </a:p>
          <a:p>
            <a:pPr marL="288550" indent="-288550">
              <a:buFont typeface="+mj-lt"/>
              <a:buAutoNum type="alphaLcPeriod" startAt="8"/>
            </a:pPr>
            <a:r>
              <a:rPr lang="en-GB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Calcium Ion Binding </a:t>
            </a:r>
          </a:p>
          <a:p>
            <a:pPr marL="288550" indent="-288550">
              <a:buFont typeface="+mj-lt"/>
              <a:buAutoNum type="alphaLcPeriod" startAt="8"/>
            </a:pPr>
            <a:r>
              <a:rPr lang="en-US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Hydrolase Activity of Glycosyl-compounds </a:t>
            </a:r>
          </a:p>
          <a:p>
            <a:pPr marL="288550" indent="-288550">
              <a:buFont typeface="+mj-lt"/>
              <a:buAutoNum type="alphaLcPeriod" startAt="8"/>
            </a:pPr>
            <a:r>
              <a:rPr lang="en-GB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Endoribonuclease Activity </a:t>
            </a:r>
          </a:p>
          <a:p>
            <a:pPr marL="288550" indent="-288550">
              <a:buFont typeface="+mj-lt"/>
              <a:buAutoNum type="alphaLcPeriod" startAt="8"/>
            </a:pPr>
            <a:r>
              <a:rPr lang="en-GB" sz="900" i="1" dirty="0">
                <a:solidFill>
                  <a:srgbClr val="000000"/>
                </a:solidFill>
                <a:latin typeface="Palatino Linotype" panose="02040502050505030304" pitchFamily="18" charset="0"/>
              </a:rPr>
              <a:t>Glycolipid Binding </a:t>
            </a:r>
          </a:p>
          <a:p>
            <a:pPr marL="288550" indent="-288550">
              <a:buAutoNum type="alphaLcPeriod" startAt="8"/>
            </a:pPr>
            <a:endParaRPr lang="en-GB" sz="900" i="1" dirty="0">
              <a:solidFill>
                <a:srgbClr val="00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193" name="CasellaDiTesto 192"/>
          <p:cNvSpPr txBox="1"/>
          <p:nvPr/>
        </p:nvSpPr>
        <p:spPr>
          <a:xfrm>
            <a:off x="3211916" y="9412818"/>
            <a:ext cx="270070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35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Palatino Linotype" panose="02040502050505030304" pitchFamily="18" charset="0"/>
              </a:rPr>
              <a:t>c) </a:t>
            </a:r>
            <a:r>
              <a:rPr lang="it-IT" sz="135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Palatino Linotype" panose="02040502050505030304" pitchFamily="18" charset="0"/>
              </a:rPr>
              <a:t>BIOLOGICAL PROCESS</a:t>
            </a:r>
            <a:endParaRPr lang="en-GB" sz="1350" b="1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194" name="Rettangolo 193"/>
          <p:cNvSpPr/>
          <p:nvPr/>
        </p:nvSpPr>
        <p:spPr>
          <a:xfrm>
            <a:off x="4486478" y="9743384"/>
            <a:ext cx="3345413" cy="15081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indent="-228600" algn="l" fontAlgn="auto">
              <a:lnSpc>
                <a:spcPct val="115000"/>
              </a:lnSpc>
              <a:spcAft>
                <a:spcPts val="0"/>
              </a:spcAft>
              <a:tabLst>
                <a:tab pos="457200" algn="l"/>
              </a:tabLst>
            </a:pPr>
            <a:r>
              <a:rPr lang="en-GB" sz="1000" i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. Immune </a:t>
            </a: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esponse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457200" indent="-228600" algn="l" fontAlgn="auto">
              <a:lnSpc>
                <a:spcPct val="115000"/>
              </a:lnSpc>
              <a:spcAft>
                <a:spcPts val="0"/>
              </a:spcAft>
              <a:tabLst>
                <a:tab pos="457200" algn="l"/>
              </a:tabLst>
            </a:pPr>
            <a:r>
              <a:rPr lang="en-GB" sz="1000" i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. Regulation </a:t>
            </a: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f Vesicle-mediate Transport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457200" indent="-228600" algn="l" fontAlgn="auto">
              <a:lnSpc>
                <a:spcPct val="115000"/>
              </a:lnSpc>
              <a:spcAft>
                <a:spcPts val="0"/>
              </a:spcAft>
              <a:tabLst>
                <a:tab pos="457200" algn="l"/>
              </a:tabLst>
            </a:pPr>
            <a:r>
              <a:rPr lang="en-GB" sz="1000" i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. Peptidase </a:t>
            </a: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ctivity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457200" indent="-228600" algn="l" fontAlgn="auto">
              <a:lnSpc>
                <a:spcPct val="115000"/>
              </a:lnSpc>
              <a:spcAft>
                <a:spcPts val="0"/>
              </a:spcAft>
              <a:tabLst>
                <a:tab pos="457200" algn="l"/>
              </a:tabLst>
            </a:pPr>
            <a:r>
              <a:rPr lang="en-GB" sz="1000" i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. Receptor </a:t>
            </a: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ctivity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457200" indent="-228600" algn="l" fontAlgn="auto">
              <a:lnSpc>
                <a:spcPct val="115000"/>
              </a:lnSpc>
              <a:spcAft>
                <a:spcPts val="0"/>
              </a:spcAft>
              <a:tabLst>
                <a:tab pos="457200" algn="l"/>
              </a:tabLst>
            </a:pPr>
            <a:r>
              <a:rPr lang="en-GB" sz="1000" i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. Tissue </a:t>
            </a: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omeostasis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457200" indent="-228600" algn="l" fontAlgn="auto">
              <a:lnSpc>
                <a:spcPct val="115000"/>
              </a:lnSpc>
              <a:spcAft>
                <a:spcPts val="0"/>
              </a:spcAft>
              <a:tabLst>
                <a:tab pos="457200" algn="l"/>
              </a:tabLst>
            </a:pPr>
            <a:r>
              <a:rPr lang="en-GB" sz="1000" i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. Extracellular </a:t>
            </a: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ructure Organization and Remodelling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457200" indent="-228600" algn="l" fontAlgn="auto">
              <a:lnSpc>
                <a:spcPct val="115000"/>
              </a:lnSpc>
              <a:spcAft>
                <a:spcPts val="0"/>
              </a:spcAft>
              <a:tabLst>
                <a:tab pos="457200" algn="l"/>
              </a:tabLst>
            </a:pPr>
            <a:r>
              <a:rPr lang="en-GB" sz="1000" i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. Phagocytosis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457200" indent="-228600" algn="l" fontAlgn="auto">
              <a:lnSpc>
                <a:spcPct val="115000"/>
              </a:lnSpc>
              <a:spcAft>
                <a:spcPts val="0"/>
              </a:spcAft>
              <a:tabLst>
                <a:tab pos="457200" algn="l"/>
              </a:tabLst>
            </a:pPr>
            <a:r>
              <a:rPr lang="en-GB" sz="1000" i="1" kern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. Regulation </a:t>
            </a: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f Cell Activation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96" name="Rettangolo 195"/>
          <p:cNvSpPr/>
          <p:nvPr/>
        </p:nvSpPr>
        <p:spPr>
          <a:xfrm>
            <a:off x="897844" y="12729020"/>
            <a:ext cx="3894525" cy="15081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000" i="1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</a:t>
            </a: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   Aminolgycan and Oligosaccharide Metabolic Process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j.    Endocytosis 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k.   Regulation of Tumour Necrosis Factor Production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l.   Blood Vessel Morphogenesis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.  Calcium-mediated Signalling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.  Post-translational Protein Modification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o.  Cofactor Transport and Catabolic Process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0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.  Neurotransmitter Transport Activity</a:t>
            </a:r>
            <a:endParaRPr lang="it-I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97" name="Rettangolo 196"/>
          <p:cNvSpPr/>
          <p:nvPr/>
        </p:nvSpPr>
        <p:spPr>
          <a:xfrm>
            <a:off x="836534" y="14425823"/>
            <a:ext cx="7423198" cy="4462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000" b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igure 4</a:t>
            </a:r>
            <a:r>
              <a:rPr lang="en-US" sz="10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. Gene ontology analysis of the </a:t>
            </a:r>
            <a:r>
              <a:rPr lang="en-US" sz="1000" i="1" dirty="0" smtClean="0">
                <a:latin typeface="Palatino Linotype" panose="02040502050505030304" pitchFamily="18" charset="0"/>
                <a:ea typeface="Times New Roman" panose="02020603050405020304" pitchFamily="18" charset="0"/>
              </a:rPr>
              <a:t>N</a:t>
            </a:r>
            <a:r>
              <a:rPr lang="en-US" sz="1000" dirty="0" smtClean="0">
                <a:latin typeface="Palatino Linotype" panose="02040502050505030304" pitchFamily="18" charset="0"/>
                <a:ea typeface="Times New Roman" panose="02020603050405020304" pitchFamily="18" charset="0"/>
              </a:rPr>
              <a:t>-glycoproteins </a:t>
            </a:r>
            <a:r>
              <a:rPr lang="en-US" sz="10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identified from all sample groups by LC-MS. Classification according to </a:t>
            </a:r>
            <a:r>
              <a:rPr lang="en-US" sz="1000" b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(a) </a:t>
            </a:r>
            <a:r>
              <a:rPr lang="en-US" sz="10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cellular component, </a:t>
            </a:r>
            <a:r>
              <a:rPr lang="en-US" sz="1000" b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(b) </a:t>
            </a:r>
            <a:r>
              <a:rPr lang="en-US" sz="10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molecular function, and </a:t>
            </a:r>
            <a:r>
              <a:rPr lang="en-US" sz="1000" b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(c) </a:t>
            </a:r>
            <a:r>
              <a:rPr lang="en-US" sz="10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biological process.</a:t>
            </a:r>
            <a:endParaRPr lang="it-IT" sz="1000" dirty="0">
              <a:effectLst/>
              <a:latin typeface="Palatino Linotype" panose="02040502050505030304" pitchFamily="18" charset="0"/>
              <a:ea typeface="Times New Roman" panose="02020603050405020304" pitchFamily="18" charset="0"/>
            </a:endParaRPr>
          </a:p>
        </p:txBody>
      </p:sp>
      <p:cxnSp>
        <p:nvCxnSpPr>
          <p:cNvPr id="205" name="Connettore diritto 204"/>
          <p:cNvCxnSpPr/>
          <p:nvPr/>
        </p:nvCxnSpPr>
        <p:spPr>
          <a:xfrm>
            <a:off x="958943" y="4034038"/>
            <a:ext cx="7154582" cy="14043"/>
          </a:xfrm>
          <a:prstGeom prst="line">
            <a:avLst/>
          </a:prstGeom>
          <a:ln w="28575"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Connettore diritto 205"/>
          <p:cNvCxnSpPr/>
          <p:nvPr/>
        </p:nvCxnSpPr>
        <p:spPr>
          <a:xfrm>
            <a:off x="1016403" y="9242057"/>
            <a:ext cx="7154582" cy="14043"/>
          </a:xfrm>
          <a:prstGeom prst="line">
            <a:avLst/>
          </a:prstGeom>
          <a:ln w="28575">
            <a:solidFill>
              <a:schemeClr val="bg2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Immagin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3509" y="9667966"/>
            <a:ext cx="7962495" cy="4737258"/>
          </a:xfrm>
          <a:prstGeom prst="rect">
            <a:avLst/>
          </a:prstGeom>
        </p:spPr>
      </p:pic>
      <p:pic>
        <p:nvPicPr>
          <p:cNvPr id="3" name="Immagin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5780" y="4718320"/>
            <a:ext cx="8205911" cy="4423216"/>
          </a:xfrm>
          <a:prstGeom prst="rect">
            <a:avLst/>
          </a:prstGeom>
        </p:spPr>
      </p:pic>
      <p:pic>
        <p:nvPicPr>
          <p:cNvPr id="29" name="Immagine 2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26574" y="503632"/>
            <a:ext cx="3872538" cy="34198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69633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6</TotalTime>
  <Words>197</Words>
  <Application>Microsoft Office PowerPoint</Application>
  <PresentationFormat>Personalizzato</PresentationFormat>
  <Paragraphs>4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ucia</dc:creator>
  <cp:lastModifiedBy>Lucia</cp:lastModifiedBy>
  <cp:revision>20</cp:revision>
  <dcterms:created xsi:type="dcterms:W3CDTF">2019-11-25T14:44:57Z</dcterms:created>
  <dcterms:modified xsi:type="dcterms:W3CDTF">2020-01-16T16:58:39Z</dcterms:modified>
</cp:coreProperties>
</file>